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30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892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0965" y="169079"/>
            <a:ext cx="3810301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4</a:t>
            </a:r>
          </a:p>
        </p:txBody>
      </p:sp>
      <p:pic>
        <p:nvPicPr>
          <p:cNvPr id="7" name="Picture 6" descr="A picture containing chart&#10;&#10;Description automatically generated">
            <a:extLst>
              <a:ext uri="{FF2B5EF4-FFF2-40B4-BE49-F238E27FC236}">
                <a16:creationId xmlns:a16="http://schemas.microsoft.com/office/drawing/2014/main" id="{DD001911-7910-2040-8802-99C8A6297D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74636" y="0"/>
            <a:ext cx="7417364" cy="686793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EE7C0D0-AE4F-6B4C-95F9-F7C6EDCFE464}"/>
              </a:ext>
            </a:extLst>
          </p:cNvPr>
          <p:cNvSpPr txBox="1"/>
          <p:nvPr/>
        </p:nvSpPr>
        <p:spPr>
          <a:xfrm>
            <a:off x="9343159" y="3768748"/>
            <a:ext cx="1204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2L Non-platinum chem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B6F83FD-9C9D-1648-8F13-D9FCA3A29D05}"/>
              </a:ext>
            </a:extLst>
          </p:cNvPr>
          <p:cNvSpPr txBox="1"/>
          <p:nvPr/>
        </p:nvSpPr>
        <p:spPr>
          <a:xfrm>
            <a:off x="9343159" y="328248"/>
            <a:ext cx="1204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2L Non-platinum chem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35A02D-AD33-0C4F-A4A6-4C8DD007554C}"/>
              </a:ext>
            </a:extLst>
          </p:cNvPr>
          <p:cNvSpPr txBox="1"/>
          <p:nvPr/>
        </p:nvSpPr>
        <p:spPr>
          <a:xfrm>
            <a:off x="5648046" y="3763574"/>
            <a:ext cx="1204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2L Non-platinum chem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4476D1-F106-8C47-A28A-CBE396EB4315}"/>
              </a:ext>
            </a:extLst>
          </p:cNvPr>
          <p:cNvSpPr txBox="1"/>
          <p:nvPr/>
        </p:nvSpPr>
        <p:spPr>
          <a:xfrm>
            <a:off x="5648045" y="342781"/>
            <a:ext cx="1204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2L Non-platinum chem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54D822-E277-1F4D-BAD9-82AE6372C981}"/>
              </a:ext>
            </a:extLst>
          </p:cNvPr>
          <p:cNvSpPr txBox="1"/>
          <p:nvPr/>
        </p:nvSpPr>
        <p:spPr>
          <a:xfrm>
            <a:off x="4562560" y="0"/>
            <a:ext cx="4908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66E4516-C611-8449-B8F9-8196D9B46ABE}"/>
              </a:ext>
            </a:extLst>
          </p:cNvPr>
          <p:cNvSpPr txBox="1"/>
          <p:nvPr/>
        </p:nvSpPr>
        <p:spPr>
          <a:xfrm>
            <a:off x="8309307" y="0"/>
            <a:ext cx="4812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5EE71CB-047F-7E4F-A404-A7A3695AD925}"/>
              </a:ext>
            </a:extLst>
          </p:cNvPr>
          <p:cNvSpPr txBox="1"/>
          <p:nvPr/>
        </p:nvSpPr>
        <p:spPr>
          <a:xfrm>
            <a:off x="4562560" y="3416747"/>
            <a:ext cx="4780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C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9D8D06E-DE12-1041-8AA4-5C0F8DE0F736}"/>
              </a:ext>
            </a:extLst>
          </p:cNvPr>
          <p:cNvSpPr txBox="1"/>
          <p:nvPr/>
        </p:nvSpPr>
        <p:spPr>
          <a:xfrm>
            <a:off x="8309307" y="3416747"/>
            <a:ext cx="4988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D)</a:t>
            </a:r>
          </a:p>
        </p:txBody>
      </p:sp>
      <p:sp>
        <p:nvSpPr>
          <p:cNvPr id="18" name="Content Placeholder 1">
            <a:extLst>
              <a:ext uri="{FF2B5EF4-FFF2-40B4-BE49-F238E27FC236}">
                <a16:creationId xmlns:a16="http://schemas.microsoft.com/office/drawing/2014/main" id="{910BB9BD-BF40-DA4C-A4DA-6F3AEDACF90D}"/>
              </a:ext>
            </a:extLst>
          </p:cNvPr>
          <p:cNvSpPr txBox="1">
            <a:spLocks/>
          </p:cNvSpPr>
          <p:nvPr/>
        </p:nvSpPr>
        <p:spPr>
          <a:xfrm>
            <a:off x="286531" y="2100069"/>
            <a:ext cx="4002124" cy="344260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Unadjusted for known treatment assignment imbalances, patients receiving 2</a:t>
            </a:r>
            <a:r>
              <a:rPr lang="en-US" sz="1400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 line ICPI vs. chemotherapy have more favorable outcomes when TMB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≥ </a:t>
            </a: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10 but not TMB &lt; 10.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Kaplan-Meier curves are unadjusted for imbalances. TTNT is shown by drug class for (A) TMB &lt; 10, and (B) TMB ≥ 10. OS is shown by drug class for (C) TMB &lt; 10, and (D) TMB ≥ 10. X-axis is truncated at 36 months. Overall survival estimates are left truncated (see Methods) with at-risk tables adjusted accordingly. Interaction models can be found in Supplemental Figure 8.</a:t>
            </a:r>
          </a:p>
        </p:txBody>
      </p:sp>
    </p:spTree>
    <p:extLst>
      <p:ext uri="{BB962C8B-B14F-4D97-AF65-F5344CB8AC3E}">
        <p14:creationId xmlns:p14="http://schemas.microsoft.com/office/powerpoint/2010/main" val="2893118144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52</Words>
  <Application>Microsoft Macintosh PowerPoint</Application>
  <PresentationFormat>Widescreen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7</cp:revision>
  <dcterms:created xsi:type="dcterms:W3CDTF">2022-06-12T16:24:02Z</dcterms:created>
  <dcterms:modified xsi:type="dcterms:W3CDTF">2022-08-13T14:33:44Z</dcterms:modified>
</cp:coreProperties>
</file>